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8" y="39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44A9E2-5E55-4703-A1D8-ADE34246A3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AE19DE8-4350-4295-A39C-C8FD533895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6F9274-D07D-4764-939A-EB1E8805D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EC46DC-0539-4657-BB7A-D7E38F3C2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CEF946-EC0B-4CF0-A743-CE6ED0820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479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396E5C-9625-40FC-870F-22A31169E3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8CA68B-C71D-4E68-B024-D0A5B51915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3FD4C1-E400-4DC0-B1E9-8FA9B689A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AC0148-9D06-4614-B0C2-64DFB749C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BBCB0D-1A69-45FA-9A9C-67CE91069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2837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6AA6033-6A10-4852-8154-3BF686CE78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53F0C3-1B55-4BD6-A92A-9C71DD46EC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78AD58-541D-41D7-91F0-04E4FCE08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39D1C0-849E-4C18-8695-E94420F43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E0A516-1BBE-49D8-A441-8A4C0F918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5682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DABC02-0193-4C48-8318-176502D3BD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8E5D1C-62E6-4109-9F82-FDBB1A3930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743FFC-BD95-4EA0-BE4C-944584DFB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1A07B4-217D-4DE6-BBBD-7A077FF163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E59125-4AB8-4A96-B1B6-BD9D44A1E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8338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B55E06-F480-439F-8496-627F52C991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7035211-C875-436A-B780-25086C28FE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17D6AA-05A2-44C4-97E8-C55218103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9C739D-EF08-4BC6-801A-02B6B4FED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8217EA-2FC8-4AAD-B204-2BE4A76DB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6851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6BB49D-8CF7-4E9B-A484-0A27CBC3D6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89D0E68-7DEB-4C10-B726-5A6430EB3C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85DF5D8-82EE-4CC7-87D4-D76A7FE432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A34B4B-25FA-41AB-9124-1FC468A7E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9771F18-BA82-4A16-B3EF-B6E6FB6C0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7C30F0D-D32D-4C10-ADC5-8653DC33D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9952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7E322A-309E-4362-93B0-35840B0BA2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2BC60C2-172F-4ADB-ACF5-2DE6C45D6C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62DEDF4-5CA0-4FF6-8BD1-FE712A1F9C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F0974AB-90FC-469A-A07E-4CB3997003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4B17B3A-F3D2-447B-9E70-61D0133B0C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49300A4-94F8-4507-91A8-28CA68409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442CEF7-F14A-4BF2-A13F-1C7C7D6EC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9AF8B27-E24C-488B-9A84-81C9E48C0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5675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959982-7F41-4331-82E5-9790D9A1A0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0C50A4F-AFA9-486A-9A2B-BE78D6427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F23DE67-E378-4710-B141-4B1AC8CC0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E0294F0-D6DA-43E6-8D7A-AF69848E0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488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A4B2168-ACDD-43F9-A9D4-D64F55363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C1A6208-9189-4F29-997B-3E49B654F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C2648D0-4916-4F18-A9FD-9F716E1AA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02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C56355-35F6-4C9C-A5AF-2D1342663E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C83027A-7EAB-4027-9835-1245FC03E0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EC7B59A-FBBC-4CE7-A7A7-4ADA98D422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B683636-D08C-473E-BF6D-4DFFBEBCB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4C6C10C-FA8B-4FE8-BDF5-8694A40FC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522F62-97D4-42B1-87F8-AF41C4E08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2060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387AF2-7F15-4CFE-9C91-0CBE41AB34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A39DCE8-F3FF-474C-BCD4-B047901838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9C1CCFC-05AB-4B5A-84B2-536991C499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29BDE0-F875-4351-AF09-3BD3E89BF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BC2AF17-BF99-4113-AAEF-67768F166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D3B3B57-B252-41D0-A0DB-856A3A35E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1940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F42FE62-C935-47C6-B7E0-38ED8CC1F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8C59978-945B-45CC-9972-CC9205419F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5FF22E-ABC9-4B25-9945-1392568B3D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15375-6E75-4F02-8176-100854F981D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F7CBE19-09A7-4A1C-9001-9E789CC6E8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83DD3E-7F8D-4305-993C-624006C80C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363DE8-6292-4F01-BCC7-B0D57D5DC6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991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7F828E91-5E7C-CD39-9F26-91E06F7F16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5803861"/>
              </p:ext>
            </p:extLst>
          </p:nvPr>
        </p:nvGraphicFramePr>
        <p:xfrm>
          <a:off x="621336" y="729866"/>
          <a:ext cx="10944001" cy="50399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9618">
                  <a:extLst>
                    <a:ext uri="{9D8B030D-6E8A-4147-A177-3AD203B41FA5}">
                      <a16:colId xmlns:a16="http://schemas.microsoft.com/office/drawing/2014/main" val="4045445319"/>
                    </a:ext>
                  </a:extLst>
                </a:gridCol>
                <a:gridCol w="809618">
                  <a:extLst>
                    <a:ext uri="{9D8B030D-6E8A-4147-A177-3AD203B41FA5}">
                      <a16:colId xmlns:a16="http://schemas.microsoft.com/office/drawing/2014/main" val="2027611753"/>
                    </a:ext>
                  </a:extLst>
                </a:gridCol>
                <a:gridCol w="1864953">
                  <a:extLst>
                    <a:ext uri="{9D8B030D-6E8A-4147-A177-3AD203B41FA5}">
                      <a16:colId xmlns:a16="http://schemas.microsoft.com/office/drawing/2014/main" val="2993594481"/>
                    </a:ext>
                  </a:extLst>
                </a:gridCol>
                <a:gridCol w="1864953">
                  <a:extLst>
                    <a:ext uri="{9D8B030D-6E8A-4147-A177-3AD203B41FA5}">
                      <a16:colId xmlns:a16="http://schemas.microsoft.com/office/drawing/2014/main" val="3146229297"/>
                    </a:ext>
                  </a:extLst>
                </a:gridCol>
                <a:gridCol w="1864953">
                  <a:extLst>
                    <a:ext uri="{9D8B030D-6E8A-4147-A177-3AD203B41FA5}">
                      <a16:colId xmlns:a16="http://schemas.microsoft.com/office/drawing/2014/main" val="3906946152"/>
                    </a:ext>
                  </a:extLst>
                </a:gridCol>
                <a:gridCol w="1864953">
                  <a:extLst>
                    <a:ext uri="{9D8B030D-6E8A-4147-A177-3AD203B41FA5}">
                      <a16:colId xmlns:a16="http://schemas.microsoft.com/office/drawing/2014/main" val="1336627063"/>
                    </a:ext>
                  </a:extLst>
                </a:gridCol>
                <a:gridCol w="1864953">
                  <a:extLst>
                    <a:ext uri="{9D8B030D-6E8A-4147-A177-3AD203B41FA5}">
                      <a16:colId xmlns:a16="http://schemas.microsoft.com/office/drawing/2014/main" val="3338389406"/>
                    </a:ext>
                  </a:extLst>
                </a:gridCol>
              </a:tblGrid>
              <a:tr h="44688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/Sex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 the enrollment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kumimoji="1" lang="en-US" altLang="ja-JP" sz="1200" dirty="0">
                          <a:latin typeface="游ゴシック" panose="020B0400000000000000" pitchFamily="50" charset="-128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­­­-6 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12 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-18 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24 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67152948"/>
                  </a:ext>
                </a:extLst>
              </a:tr>
              <a:tr h="571129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/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EL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EL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EL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aseline="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IS/ELD</a:t>
                      </a:r>
                      <a:r>
                        <a:rPr kumimoji="1" lang="en-US" altLang="ja-JP" sz="1200" baseline="0" dirty="0">
                          <a:solidFill>
                            <a:srgbClr val="FF0000"/>
                          </a:solidFill>
                          <a:latin typeface="游ゴシック" panose="020B0400000000000000" pitchFamily="50" charset="-128"/>
                          <a:ea typeface="+mn-ea"/>
                          <a:cs typeface="Arial" panose="020B0604020202020204" pitchFamily="34" charset="0"/>
                        </a:rPr>
                        <a:t>→</a:t>
                      </a:r>
                      <a:r>
                        <a:rPr kumimoji="1" lang="en-US" altLang="ja-JP" sz="1200" baseline="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PTD (13M~) </a:t>
                      </a:r>
                      <a:endParaRPr kumimoji="1" lang="en-US" altLang="ja-JP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aseline="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PTD</a:t>
                      </a:r>
                      <a:endParaRPr kumimoji="1" lang="ja-JP" altLang="en-US" sz="1200" baseline="-250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55447386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/F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B/CA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B/CA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B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MO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MO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37928646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/F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B/CA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B/CA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B/CA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B/CA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B/CA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70941736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solidFill>
                            <a:srgbClr val="0066C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66C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66C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/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66C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66C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66C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66C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66C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30843470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/F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/ELD/VK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/ELD/VK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/ELD/VK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/ELD/VK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/ELD/VK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46235882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/F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LX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LX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40484374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120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/F</a:t>
                      </a:r>
                      <a:endParaRPr kumimoji="1" lang="ja-JP" altLang="en-US" sz="120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ALF</a:t>
                      </a:r>
                      <a:endParaRPr kumimoji="1" lang="ja-JP" altLang="en-US" sz="120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ALF</a:t>
                      </a:r>
                      <a:endParaRPr kumimoji="1" lang="ja-JP" altLang="en-US" sz="120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ALF</a:t>
                      </a:r>
                      <a:endParaRPr kumimoji="1" lang="ja-JP" altLang="en-US" sz="120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ALF</a:t>
                      </a:r>
                      <a:endParaRPr kumimoji="1" lang="ja-JP" altLang="en-US" sz="120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ALF</a:t>
                      </a:r>
                      <a:endParaRPr kumimoji="1" lang="ja-JP" altLang="en-US" sz="120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00140958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/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L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L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L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L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L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51030465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/F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N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35338994"/>
                  </a:ext>
                </a:extLst>
              </a:tr>
              <a:tr h="44688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/F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/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D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46549951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3FD42F8-401C-861F-0EC5-B44BE26EBF33}"/>
              </a:ext>
            </a:extLst>
          </p:cNvPr>
          <p:cNvSpPr txBox="1"/>
          <p:nvPr/>
        </p:nvSpPr>
        <p:spPr>
          <a:xfrm>
            <a:off x="560381" y="5900380"/>
            <a:ext cx="111494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, male; F, female; Bisphosphonate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（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LN, alendronate; RIS, risedronate; MINO,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inodronate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; ZOL, zoledronate);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ctivated vitamin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D</a:t>
            </a:r>
            <a:r>
              <a:rPr kumimoji="1" lang="en-US" altLang="ja-JP" sz="12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3 </a:t>
            </a:r>
            <a:r>
              <a:rPr kumimoji="1" lang="en-US" altLang="ja-JP" sz="1200" b="0" i="0" u="none" strike="noStrike" kern="1200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nalog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(ELD, eldecalcitol; ALF,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lfacalcidol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; TPTD, teriparatide; DMAB, denosumab (anti-RANKL antibody); ROMO,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romosozuma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(anti-sclerostin antibody); Selective estrogen receptor modulator (RLX, raloxifene); VK2, vitamin K2; CAD; calcium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·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native vitamin D supplement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8E7D66B-FCE5-6BAB-DB8D-C339C962EF2D}"/>
              </a:ext>
            </a:extLst>
          </p:cNvPr>
          <p:cNvSpPr txBox="1"/>
          <p:nvPr/>
        </p:nvSpPr>
        <p:spPr>
          <a:xfrm>
            <a:off x="382135" y="96224"/>
            <a:ext cx="79672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nline Resource</a:t>
            </a: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1. Osteoporosis treatment </a:t>
            </a:r>
            <a:r>
              <a:rPr lang="en-US" altLang="ja-JP" sz="1600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ver the </a:t>
            </a: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4-month follow-up period</a:t>
            </a:r>
            <a:endParaRPr kumimoji="1" lang="ja-JP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9240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303</Words>
  <Application>Microsoft Office PowerPoint</Application>
  <PresentationFormat>ワイド画面</PresentationFormat>
  <Paragraphs>7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舩元</dc:creator>
  <cp:lastModifiedBy>敏博 鶴田</cp:lastModifiedBy>
  <cp:revision>16</cp:revision>
  <cp:lastPrinted>2023-06-19T23:21:10Z</cp:lastPrinted>
  <dcterms:created xsi:type="dcterms:W3CDTF">2023-04-27T08:20:37Z</dcterms:created>
  <dcterms:modified xsi:type="dcterms:W3CDTF">2023-09-06T23:39:19Z</dcterms:modified>
</cp:coreProperties>
</file>